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9" r:id="rId3"/>
    <p:sldId id="258" r:id="rId4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50" d="100"/>
          <a:sy n="150" d="100"/>
        </p:scale>
        <p:origin x="1590" y="-6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05ECB-080E-4AD6-B3D2-2D8CD5008182}" type="datetimeFigureOut">
              <a:rPr lang="en-US" smtClean="0"/>
              <a:t>2020/10/2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C0CF5-9BD2-4BED-96E4-557D8F05EB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43933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05ECB-080E-4AD6-B3D2-2D8CD5008182}" type="datetimeFigureOut">
              <a:rPr lang="en-US" smtClean="0"/>
              <a:t>2020/10/2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C0CF5-9BD2-4BED-96E4-557D8F05EB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360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05ECB-080E-4AD6-B3D2-2D8CD5008182}" type="datetimeFigureOut">
              <a:rPr lang="en-US" smtClean="0"/>
              <a:t>2020/10/2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C0CF5-9BD2-4BED-96E4-557D8F05EB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19877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05ECB-080E-4AD6-B3D2-2D8CD5008182}" type="datetimeFigureOut">
              <a:rPr lang="en-US" smtClean="0"/>
              <a:t>2020/10/2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C0CF5-9BD2-4BED-96E4-557D8F05EB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61088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05ECB-080E-4AD6-B3D2-2D8CD5008182}" type="datetimeFigureOut">
              <a:rPr lang="en-US" smtClean="0"/>
              <a:t>2020/10/2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C0CF5-9BD2-4BED-96E4-557D8F05EB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59283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05ECB-080E-4AD6-B3D2-2D8CD5008182}" type="datetimeFigureOut">
              <a:rPr lang="en-US" smtClean="0"/>
              <a:t>2020/10/2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C0CF5-9BD2-4BED-96E4-557D8F05EB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12990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05ECB-080E-4AD6-B3D2-2D8CD5008182}" type="datetimeFigureOut">
              <a:rPr lang="en-US" smtClean="0"/>
              <a:t>2020/10/2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C0CF5-9BD2-4BED-96E4-557D8F05EB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3795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05ECB-080E-4AD6-B3D2-2D8CD5008182}" type="datetimeFigureOut">
              <a:rPr lang="en-US" smtClean="0"/>
              <a:t>2020/10/2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C0CF5-9BD2-4BED-96E4-557D8F05EB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0357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05ECB-080E-4AD6-B3D2-2D8CD5008182}" type="datetimeFigureOut">
              <a:rPr lang="en-US" smtClean="0"/>
              <a:t>2020/10/2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C0CF5-9BD2-4BED-96E4-557D8F05EB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14832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05ECB-080E-4AD6-B3D2-2D8CD5008182}" type="datetimeFigureOut">
              <a:rPr lang="en-US" smtClean="0"/>
              <a:t>2020/10/2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C0CF5-9BD2-4BED-96E4-557D8F05EB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73278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F05ECB-080E-4AD6-B3D2-2D8CD5008182}" type="datetimeFigureOut">
              <a:rPr lang="en-US" smtClean="0"/>
              <a:t>2020/10/2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C0CF5-9BD2-4BED-96E4-557D8F05EB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6015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F05ECB-080E-4AD6-B3D2-2D8CD5008182}" type="datetimeFigureOut">
              <a:rPr lang="en-US" smtClean="0"/>
              <a:t>2020/10/2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8C0CF5-9BD2-4BED-96E4-557D8F05EB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51467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4784" y="1050913"/>
            <a:ext cx="1889383" cy="1673356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4167" y="1050913"/>
            <a:ext cx="1889383" cy="1673356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3550" y="1050913"/>
            <a:ext cx="1889383" cy="167335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4784" y="2724269"/>
            <a:ext cx="1889383" cy="167335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4167" y="2724269"/>
            <a:ext cx="1889383" cy="1673356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3550" y="2724269"/>
            <a:ext cx="1889383" cy="1673356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4784" y="4397625"/>
            <a:ext cx="1889383" cy="1673356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4167" y="4397625"/>
            <a:ext cx="1889383" cy="1673356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3550" y="4397625"/>
            <a:ext cx="1889383" cy="1673356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4784" y="6070981"/>
            <a:ext cx="1889383" cy="1673356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4167" y="6070981"/>
            <a:ext cx="1889383" cy="1673356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3550" y="6070981"/>
            <a:ext cx="1889383" cy="1673356"/>
          </a:xfrm>
          <a:prstGeom prst="rect">
            <a:avLst/>
          </a:prstGeom>
        </p:spPr>
      </p:pic>
      <p:grpSp>
        <p:nvGrpSpPr>
          <p:cNvPr id="16" name="Group 15"/>
          <p:cNvGrpSpPr/>
          <p:nvPr/>
        </p:nvGrpSpPr>
        <p:grpSpPr>
          <a:xfrm>
            <a:off x="2670256" y="488382"/>
            <a:ext cx="1718502" cy="535531"/>
            <a:chOff x="-886" y="3430288"/>
            <a:chExt cx="1718502" cy="535531"/>
          </a:xfrm>
        </p:grpSpPr>
        <p:pic>
          <p:nvPicPr>
            <p:cNvPr id="17" name="Picture 16"/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096" t="3561" r="39854" b="90121"/>
            <a:stretch/>
          </p:blipFill>
          <p:spPr>
            <a:xfrm>
              <a:off x="1019" y="3486152"/>
              <a:ext cx="152400" cy="140970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349" t="42666" r="46055" b="50674"/>
            <a:stretch/>
          </p:blipFill>
          <p:spPr>
            <a:xfrm>
              <a:off x="-886" y="3627122"/>
              <a:ext cx="140970" cy="148590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1381" t="21034" r="3855" b="73929"/>
            <a:stretch/>
          </p:blipFill>
          <p:spPr>
            <a:xfrm>
              <a:off x="9525" y="3790950"/>
              <a:ext cx="120015" cy="112396"/>
            </a:xfrm>
            <a:prstGeom prst="rect">
              <a:avLst/>
            </a:prstGeom>
          </p:spPr>
        </p:pic>
        <p:sp>
          <p:nvSpPr>
            <p:cNvPr id="20" name="TextBox 19"/>
            <p:cNvSpPr txBox="1"/>
            <p:nvPr/>
          </p:nvSpPr>
          <p:spPr>
            <a:xfrm>
              <a:off x="79026" y="3430288"/>
              <a:ext cx="1638590" cy="5355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CA" sz="800" dirty="0">
                  <a:latin typeface="Arial" panose="020B0604020202020204" pitchFamily="34" charset="0"/>
                  <a:cs typeface="Arial" panose="020B0604020202020204" pitchFamily="34" charset="0"/>
                </a:rPr>
                <a:t>PHMDS large deletion (training)</a:t>
              </a:r>
            </a:p>
            <a:p>
              <a:pPr>
                <a:lnSpc>
                  <a:spcPct val="120000"/>
                </a:lnSpc>
              </a:pPr>
              <a:r>
                <a:rPr lang="en-CA" sz="800" dirty="0">
                  <a:latin typeface="Arial" panose="020B0604020202020204" pitchFamily="34" charset="0"/>
                  <a:cs typeface="Arial" panose="020B0604020202020204" pitchFamily="34" charset="0"/>
                </a:rPr>
                <a:t>PHMDS large deletion (testing)</a:t>
              </a:r>
            </a:p>
            <a:p>
              <a:pPr>
                <a:lnSpc>
                  <a:spcPct val="120000"/>
                </a:lnSpc>
              </a:pPr>
              <a:r>
                <a:rPr lang="en-CA" sz="800" dirty="0">
                  <a:latin typeface="Arial" panose="020B0604020202020204" pitchFamily="34" charset="0"/>
                  <a:cs typeface="Arial" panose="020B0604020202020204" pitchFamily="34" charset="0"/>
                </a:rPr>
                <a:t>Controls (training)</a:t>
              </a:r>
            </a:p>
          </p:txBody>
        </p: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FDF7FF59-A9BE-4D69-8667-69303698DA85}"/>
              </a:ext>
            </a:extLst>
          </p:cNvPr>
          <p:cNvSpPr txBox="1"/>
          <p:nvPr/>
        </p:nvSpPr>
        <p:spPr>
          <a:xfrm>
            <a:off x="180975" y="8639175"/>
            <a:ext cx="2383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262190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C987AEB-3795-440C-BCFF-2D9E4A8D070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66" t="24839" r="1946" b="14716"/>
          <a:stretch/>
        </p:blipFill>
        <p:spPr>
          <a:xfrm>
            <a:off x="349249" y="600568"/>
            <a:ext cx="6280151" cy="189128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67BFE1D-B10A-4B82-B5C1-F9CD89087B62}"/>
              </a:ext>
            </a:extLst>
          </p:cNvPr>
          <p:cNvSpPr txBox="1"/>
          <p:nvPr/>
        </p:nvSpPr>
        <p:spPr>
          <a:xfrm>
            <a:off x="180975" y="8639175"/>
            <a:ext cx="2383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2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05DADAC-E3B0-4D59-9B10-9ECCFEEC42F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0975" y="2814858"/>
            <a:ext cx="6280151" cy="29157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67366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53F4FF6-506A-42E5-910E-822CDEC0329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77420"/>
            <a:ext cx="6858000" cy="377559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FA71391C-34E2-4E54-909B-E1D21800E4D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4207097"/>
            <a:ext cx="6858000" cy="3923381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90D6A342-9965-4EBA-9B93-75EA4712517E}"/>
              </a:ext>
            </a:extLst>
          </p:cNvPr>
          <p:cNvSpPr txBox="1"/>
          <p:nvPr/>
        </p:nvSpPr>
        <p:spPr>
          <a:xfrm>
            <a:off x="180975" y="8639175"/>
            <a:ext cx="2383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3</a:t>
            </a:r>
          </a:p>
        </p:txBody>
      </p:sp>
    </p:spTree>
    <p:extLst>
      <p:ext uri="{BB962C8B-B14F-4D97-AF65-F5344CB8AC3E}">
        <p14:creationId xmlns:p14="http://schemas.microsoft.com/office/powerpoint/2010/main" val="5078080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</TotalTime>
  <Words>25</Words>
  <Application>Microsoft Office PowerPoint</Application>
  <PresentationFormat>Letter Paper (8.5x11 in)</PresentationFormat>
  <Paragraphs>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ila Schenkel</dc:creator>
  <cp:lastModifiedBy>Laila Schenkel</cp:lastModifiedBy>
  <cp:revision>4</cp:revision>
  <dcterms:created xsi:type="dcterms:W3CDTF">2020-10-26T21:10:28Z</dcterms:created>
  <dcterms:modified xsi:type="dcterms:W3CDTF">2020-10-27T14:11:11Z</dcterms:modified>
</cp:coreProperties>
</file>